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62"/>
  </p:normalViewPr>
  <p:slideViewPr>
    <p:cSldViewPr snapToGrid="0" snapToObjects="1">
      <p:cViewPr varScale="1">
        <p:scale>
          <a:sx n="87" d="100"/>
          <a:sy n="87" d="100"/>
        </p:scale>
        <p:origin x="666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58A0EDB9-150D-BC44-9DE6-6F87C180DEE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xmlns="" id="{8C0BA033-6C77-BF40-AF12-EA641A16A8E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AD57FD51-75A1-D546-AB25-66B40356BE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D58FA8-D4F7-E44A-9B4E-505537ADFA77}" type="datetimeFigureOut">
              <a:rPr lang="en-US" smtClean="0"/>
              <a:t>31-May-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3DE43F41-E549-284B-83D2-547AEE43A4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9E3B2DD0-3780-BF45-8E0A-031454174A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4E1553-322F-DC40-B43C-C9E7234D9A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47490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98685BF1-F947-644D-B7C3-8852F1712E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3505E977-9451-5F4F-8174-54F81097DFB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09F6573D-7967-9649-9B81-D621C1D3E8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D58FA8-D4F7-E44A-9B4E-505537ADFA77}" type="datetimeFigureOut">
              <a:rPr lang="en-US" smtClean="0"/>
              <a:t>31-May-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A3516BA7-1128-E747-92D2-879A6AD3F0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6AC0AC49-FF5F-1A4B-9CB9-AA61546F7B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4E1553-322F-DC40-B43C-C9E7234D9A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39413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xmlns="" id="{2EFCCCFD-8A87-7341-BF80-BE5D4F14132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45BEE975-AE36-6B4B-B546-1605B49A970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9593C86D-1CBF-7348-8B9C-DB87D86732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D58FA8-D4F7-E44A-9B4E-505537ADFA77}" type="datetimeFigureOut">
              <a:rPr lang="en-US" smtClean="0"/>
              <a:t>31-May-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236D6285-9453-6048-901A-86E39FEF32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1F4A94EF-04D2-E942-A43A-152BFC1F9C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4E1553-322F-DC40-B43C-C9E7234D9A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44243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17882955-3212-D345-8AC4-0475EC5AD4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54CE9146-9A11-5442-AA24-2D5826794CE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88961702-F835-6E46-AB1E-EB959282DD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D58FA8-D4F7-E44A-9B4E-505537ADFA77}" type="datetimeFigureOut">
              <a:rPr lang="en-US" smtClean="0"/>
              <a:t>31-May-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F9C2BA31-FD29-BE43-8612-88F641E270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61FF4901-A1E2-E343-8452-CE5A140671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4E1553-322F-DC40-B43C-C9E7234D9A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78287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42035BB5-3D80-A841-B5EF-30EFA42B5A3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52501FCA-4E08-3245-93F6-99C4A70A00B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658D9C5C-4EAD-434A-ADFD-E32D890E7F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D58FA8-D4F7-E44A-9B4E-505537ADFA77}" type="datetimeFigureOut">
              <a:rPr lang="en-US" smtClean="0"/>
              <a:t>31-May-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D72F4313-3297-C04D-9CFE-FFAD03E9E5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618C72C0-FE8C-C04C-852C-C942A5A132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4E1553-322F-DC40-B43C-C9E7234D9A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04630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04999F92-E75C-0D42-B4D4-96D0F096F2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6B86984F-C3C6-9B4E-A966-5C62D0E93D0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F38D2078-2279-094F-950F-815093D1AB9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17EEA597-1D1C-1C49-B9E7-6AA742D7A0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D58FA8-D4F7-E44A-9B4E-505537ADFA77}" type="datetimeFigureOut">
              <a:rPr lang="en-US" smtClean="0"/>
              <a:t>31-May-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DB883B42-80C3-E74D-91CD-ADA966365B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FAFAB25A-2AB6-4D4B-BC7A-DD6A88DBC1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4E1553-322F-DC40-B43C-C9E7234D9A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85747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3767DC06-6442-3546-A83E-AD34E26E9C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A9001C01-590E-FD42-949C-C09312EC208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9E0E256A-8310-544A-A1E8-7D818F5EEAB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xmlns="" id="{470FE975-1E30-F047-8011-B35F643BFC8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xmlns="" id="{351AB0BA-C063-AC4A-BD14-B159C3C21CB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xmlns="" id="{790DF2A2-D55D-CE48-80B1-9B7157C3B3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D58FA8-D4F7-E44A-9B4E-505537ADFA77}" type="datetimeFigureOut">
              <a:rPr lang="en-US" smtClean="0"/>
              <a:t>31-May-18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xmlns="" id="{98FDEBAB-FD8E-5742-9BB7-5A15B73ABA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xmlns="" id="{F94D23D7-F315-8D4F-9602-1785BEA8D5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4E1553-322F-DC40-B43C-C9E7234D9A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20006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AF975871-FD9F-1443-A3AA-0CA1C6C374B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xmlns="" id="{3F0A25B0-96B1-C042-B968-043EBA8F0D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D58FA8-D4F7-E44A-9B4E-505537ADFA77}" type="datetimeFigureOut">
              <a:rPr lang="en-US" smtClean="0"/>
              <a:t>31-May-18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xmlns="" id="{73140891-0C67-C54C-B32A-09FA79A90F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xmlns="" id="{93409BA7-D52A-7442-ADCD-347522903D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4E1553-322F-DC40-B43C-C9E7234D9A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05275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xmlns="" id="{CF3E37CF-5669-5848-BEBA-2E262F37B0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D58FA8-D4F7-E44A-9B4E-505537ADFA77}" type="datetimeFigureOut">
              <a:rPr lang="en-US" smtClean="0"/>
              <a:t>31-May-18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xmlns="" id="{133492C6-CD4C-8542-A84E-65F202BF33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xmlns="" id="{5F25481F-E0D1-4249-93C0-CEB804BF01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4E1553-322F-DC40-B43C-C9E7234D9A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17384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21C19750-2936-3D43-812B-9B949DC4B1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32DA05FC-4708-F342-B526-AB7B62576BB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8AB8B704-160F-994A-9E83-A98743E1C9D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50F0BB72-C06C-1341-A464-8EAFA1720E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D58FA8-D4F7-E44A-9B4E-505537ADFA77}" type="datetimeFigureOut">
              <a:rPr lang="en-US" smtClean="0"/>
              <a:t>31-May-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94B2D9DF-C81A-3947-8C54-2B936A4767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53B07430-2FC4-6E40-9316-905BA36D60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4E1553-322F-DC40-B43C-C9E7234D9A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89165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09A6AAE1-9DFD-6142-86B3-62B51569F8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xmlns="" id="{68FCD9FC-1095-AE47-AF07-85B58B13C3E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CEE96E47-560D-BE4B-A0A8-E62A849C213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286BC162-C2BA-D747-ACEA-BE097D0B86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D58FA8-D4F7-E44A-9B4E-505537ADFA77}" type="datetimeFigureOut">
              <a:rPr lang="en-US" smtClean="0"/>
              <a:t>31-May-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E6D7FA0D-3727-214E-BBFF-AFB50B7F8B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84283349-17D8-6F4E-B42D-6CA4462A59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4E1553-322F-DC40-B43C-C9E7234D9A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24085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xmlns="" id="{A84DDD66-D7F7-AA4F-9915-89AF13B3F30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3103AFC9-BFE0-D74A-A5A7-06E8E943827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0A26D7E2-3705-1046-802A-BD6B46D5084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D58FA8-D4F7-E44A-9B4E-505537ADFA77}" type="datetimeFigureOut">
              <a:rPr lang="en-US" smtClean="0"/>
              <a:t>31-May-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EA78E5B2-435B-4F48-8432-33FEEB913E5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F2B68497-534B-CD42-B9FC-D9617E37463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4E1553-322F-DC40-B43C-C9E7234D9A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2371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4" descr="adipo_4-11-08">
            <a:extLst>
              <a:ext uri="{FF2B5EF4-FFF2-40B4-BE49-F238E27FC236}">
                <a16:creationId xmlns:a16="http://schemas.microsoft.com/office/drawing/2014/main" xmlns="" id="{14A275C7-C353-BD40-96A6-396AC92F068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print">
            <a:alphaModFix/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colorTemperature colorTemp="6348"/>
                    </a14:imgEffect>
                    <a14:imgEffect>
                      <a14:saturation sat="0"/>
                    </a14:imgEffect>
                  </a14:imgLayer>
                </a14:imgProps>
              </a:ext>
            </a:extLst>
          </a:blip>
          <a:srcRect l="22343" t="55864" r="28540" b="34062"/>
          <a:stretch>
            <a:fillRect/>
          </a:stretch>
        </p:blipFill>
        <p:spPr bwMode="auto">
          <a:xfrm>
            <a:off x="4126091" y="2750114"/>
            <a:ext cx="3581400" cy="533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7" name="TextBox 23">
            <a:extLst>
              <a:ext uri="{FF2B5EF4-FFF2-40B4-BE49-F238E27FC236}">
                <a16:creationId xmlns:a16="http://schemas.microsoft.com/office/drawing/2014/main" xmlns="" id="{8BD79560-29A6-654F-BE21-774822E7336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068447" y="2799212"/>
            <a:ext cx="1295400" cy="369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CA" b="1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xmlns="" id="{264A9352-DC9D-2C4B-B8E5-D7C78E680253}"/>
              </a:ext>
            </a:extLst>
          </p:cNvPr>
          <p:cNvSpPr/>
          <p:nvPr/>
        </p:nvSpPr>
        <p:spPr>
          <a:xfrm>
            <a:off x="973778" y="4353747"/>
            <a:ext cx="9640676" cy="129407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b="1" dirty="0"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Representative PCR reactions for LMP1 of EBV in 4 cervical cancer samples</a:t>
            </a:r>
            <a:r>
              <a:rPr lang="en-US" dirty="0"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. Chronic B leukemia cells were used as positive control (PC); and human normal cervical cells were utilized as negative control (NC). </a:t>
            </a:r>
            <a:endParaRPr lang="en-CA" dirty="0">
              <a:latin typeface="Calibri" panose="020F0502020204030204" pitchFamily="34" charset="0"/>
              <a:ea typeface="MS Mincho" panose="02020609040205080304" pitchFamily="49" charset="-128"/>
              <a:cs typeface="Arial" panose="020B0604020202020204" pitchFamily="34" charset="0"/>
            </a:endParaRP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xmlns="" id="{A35EF994-D72E-9045-9E50-D9AAFF6051C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14216" y="2143381"/>
            <a:ext cx="3581400" cy="541417"/>
          </a:xfrm>
          <a:prstGeom prst="rect">
            <a:avLst/>
          </a:prstGeom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xmlns="" id="{CFB24A90-AFDD-5741-834C-7D7DAFCE1529}"/>
              </a:ext>
            </a:extLst>
          </p:cNvPr>
          <p:cNvSpPr/>
          <p:nvPr/>
        </p:nvSpPr>
        <p:spPr>
          <a:xfrm>
            <a:off x="3196189" y="2238353"/>
            <a:ext cx="80021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LMP1</a:t>
            </a:r>
            <a:endParaRPr lang="en-US" b="1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16B5D606-7F83-5349-83B5-86CD19B54C64}"/>
              </a:ext>
            </a:extLst>
          </p:cNvPr>
          <p:cNvSpPr txBox="1"/>
          <p:nvPr/>
        </p:nvSpPr>
        <p:spPr>
          <a:xfrm>
            <a:off x="4126091" y="3348845"/>
            <a:ext cx="41296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  1         2         3          4       PC        NC           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xmlns="" id="{71A16C5F-4972-E443-BE33-6D921D92815A}"/>
              </a:ext>
            </a:extLst>
          </p:cNvPr>
          <p:cNvSpPr txBox="1"/>
          <p:nvPr/>
        </p:nvSpPr>
        <p:spPr>
          <a:xfrm>
            <a:off x="973777" y="676894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bs-Latn-BA" b="1" smtClean="0">
                <a:latin typeface="Arial" panose="020B0604020202020204" pitchFamily="34" charset="0"/>
                <a:cs typeface="Arial" panose="020B0604020202020204" pitchFamily="34" charset="0"/>
              </a:rPr>
              <a:t>Figure 1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887122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3</TotalTime>
  <Words>50</Words>
  <Application>Microsoft Office PowerPoint</Application>
  <PresentationFormat>Widescreen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MS Mincho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a-Eddin Al Moustafa</dc:creator>
  <cp:lastModifiedBy>Semir Vranić</cp:lastModifiedBy>
  <cp:revision>7</cp:revision>
  <cp:lastPrinted>2018-05-30T18:11:01Z</cp:lastPrinted>
  <dcterms:created xsi:type="dcterms:W3CDTF">2018-05-30T17:51:32Z</dcterms:created>
  <dcterms:modified xsi:type="dcterms:W3CDTF">2018-05-31T04:32:28Z</dcterms:modified>
</cp:coreProperties>
</file>